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31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0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2.tiff"/><Relationship Id="rId7" Type="http://schemas.openxmlformats.org/officeDocument/2006/relationships/image" Target="../media/image5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7.emf"/><Relationship Id="rId5" Type="http://schemas.openxmlformats.org/officeDocument/2006/relationships/image" Target="../media/image4.tiff"/><Relationship Id="rId10" Type="http://schemas.openxmlformats.org/officeDocument/2006/relationships/oleObject" Target="../embeddings/oleObject3.bin"/><Relationship Id="rId4" Type="http://schemas.openxmlformats.org/officeDocument/2006/relationships/image" Target="../media/image3.tiff"/><Relationship Id="rId9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85"/>
          <p:cNvGrpSpPr/>
          <p:nvPr/>
        </p:nvGrpSpPr>
        <p:grpSpPr>
          <a:xfrm>
            <a:off x="721670" y="962913"/>
            <a:ext cx="10744208" cy="3896309"/>
            <a:chOff x="352326" y="848613"/>
            <a:chExt cx="10744208" cy="3896309"/>
          </a:xfrm>
        </p:grpSpPr>
        <p:grpSp>
          <p:nvGrpSpPr>
            <p:cNvPr id="54" name="Group 53"/>
            <p:cNvGrpSpPr/>
            <p:nvPr/>
          </p:nvGrpSpPr>
          <p:grpSpPr>
            <a:xfrm>
              <a:off x="352326" y="864002"/>
              <a:ext cx="3406469" cy="3880920"/>
              <a:chOff x="322323" y="1069742"/>
              <a:chExt cx="3406469" cy="3880920"/>
            </a:xfrm>
          </p:grpSpPr>
          <p:grpSp>
            <p:nvGrpSpPr>
              <p:cNvPr id="33" name="Group 32"/>
              <p:cNvGrpSpPr/>
              <p:nvPr/>
            </p:nvGrpSpPr>
            <p:grpSpPr>
              <a:xfrm>
                <a:off x="589730" y="1671290"/>
                <a:ext cx="2565052" cy="419542"/>
                <a:chOff x="107045" y="514750"/>
                <a:chExt cx="2565052" cy="419542"/>
              </a:xfrm>
            </p:grpSpPr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7045" y="514750"/>
                  <a:ext cx="1828800" cy="419542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sp>
              <p:nvSpPr>
                <p:cNvPr id="35" name="TextBox 34"/>
                <p:cNvSpPr txBox="1"/>
                <p:nvPr/>
              </p:nvSpPr>
              <p:spPr>
                <a:xfrm>
                  <a:off x="1888128" y="595326"/>
                  <a:ext cx="78396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AG</a:t>
                  </a:r>
                </a:p>
              </p:txBody>
            </p:sp>
          </p:grpSp>
          <p:grpSp>
            <p:nvGrpSpPr>
              <p:cNvPr id="36" name="Group 35"/>
              <p:cNvGrpSpPr/>
              <p:nvPr/>
            </p:nvGrpSpPr>
            <p:grpSpPr>
              <a:xfrm>
                <a:off x="591840" y="2700734"/>
                <a:ext cx="2570873" cy="424541"/>
                <a:chOff x="94821" y="1055735"/>
                <a:chExt cx="2570873" cy="424541"/>
              </a:xfrm>
            </p:grpSpPr>
            <p:pic>
              <p:nvPicPr>
                <p:cNvPr id="37" name="Picture 36"/>
                <p:cNvPicPr>
                  <a:picLocks noChangeAspect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4821" y="1055735"/>
                  <a:ext cx="1828800" cy="424541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sp>
              <p:nvSpPr>
                <p:cNvPr id="38" name="TextBox 37"/>
                <p:cNvSpPr txBox="1"/>
                <p:nvPr/>
              </p:nvSpPr>
              <p:spPr>
                <a:xfrm>
                  <a:off x="1881725" y="1115246"/>
                  <a:ext cx="78396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S</a:t>
                  </a:r>
                </a:p>
              </p:txBody>
            </p:sp>
          </p:grpSp>
          <p:grpSp>
            <p:nvGrpSpPr>
              <p:cNvPr id="39" name="Group 38"/>
              <p:cNvGrpSpPr/>
              <p:nvPr/>
            </p:nvGrpSpPr>
            <p:grpSpPr>
              <a:xfrm>
                <a:off x="592070" y="2144509"/>
                <a:ext cx="3136722" cy="495760"/>
                <a:chOff x="97361" y="1622841"/>
                <a:chExt cx="3136722" cy="495760"/>
              </a:xfrm>
            </p:grpSpPr>
            <p:pic>
              <p:nvPicPr>
                <p:cNvPr id="40" name="Picture 39"/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7361" y="1622841"/>
                  <a:ext cx="1828800" cy="495760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sp>
              <p:nvSpPr>
                <p:cNvPr id="41" name="TextBox 40"/>
                <p:cNvSpPr txBox="1"/>
                <p:nvPr/>
              </p:nvSpPr>
              <p:spPr>
                <a:xfrm>
                  <a:off x="1884035" y="1722228"/>
                  <a:ext cx="135004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AS G12D</a:t>
                  </a:r>
                </a:p>
              </p:txBody>
            </p:sp>
          </p:grpSp>
          <p:grpSp>
            <p:nvGrpSpPr>
              <p:cNvPr id="44" name="Group 43"/>
              <p:cNvGrpSpPr/>
              <p:nvPr/>
            </p:nvGrpSpPr>
            <p:grpSpPr>
              <a:xfrm>
                <a:off x="592303" y="3183763"/>
                <a:ext cx="2652942" cy="367921"/>
                <a:chOff x="628722" y="3113963"/>
                <a:chExt cx="2652942" cy="367921"/>
              </a:xfrm>
            </p:grpSpPr>
            <p:pic>
              <p:nvPicPr>
                <p:cNvPr id="42" name="Picture 41"/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28722" y="3113963"/>
                  <a:ext cx="1828800" cy="367921"/>
                </a:xfrm>
                <a:prstGeom prst="rect">
                  <a:avLst/>
                </a:prstGeom>
                <a:ln w="3175"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</p:pic>
            <p:sp>
              <p:nvSpPr>
                <p:cNvPr id="43" name="TextBox 42"/>
                <p:cNvSpPr txBox="1"/>
                <p:nvPr/>
              </p:nvSpPr>
              <p:spPr>
                <a:xfrm>
                  <a:off x="2407232" y="3138154"/>
                  <a:ext cx="8744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</a:p>
              </p:txBody>
            </p:sp>
          </p:grpSp>
          <p:grpSp>
            <p:nvGrpSpPr>
              <p:cNvPr id="45" name="Group 44"/>
              <p:cNvGrpSpPr/>
              <p:nvPr/>
            </p:nvGrpSpPr>
            <p:grpSpPr>
              <a:xfrm>
                <a:off x="709877" y="3484953"/>
                <a:ext cx="1658593" cy="1465709"/>
                <a:chOff x="2400110" y="2691516"/>
                <a:chExt cx="1658593" cy="1465709"/>
              </a:xfrm>
            </p:grpSpPr>
            <p:sp>
              <p:nvSpPr>
                <p:cNvPr id="46" name="TextBox 45"/>
                <p:cNvSpPr txBox="1"/>
                <p:nvPr/>
              </p:nvSpPr>
              <p:spPr>
                <a:xfrm rot="16200000">
                  <a:off x="2148467" y="2950723"/>
                  <a:ext cx="78028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</a:t>
                  </a: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 rot="16200000">
                  <a:off x="2579008" y="2927577"/>
                  <a:ext cx="7491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  </a:t>
                  </a: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 rot="16200000">
                  <a:off x="3050836" y="2947628"/>
                  <a:ext cx="7090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4</a:t>
                  </a: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 rot="16200000">
                  <a:off x="3454997" y="2975612"/>
                  <a:ext cx="8186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5</a:t>
                  </a:r>
                </a:p>
              </p:txBody>
            </p:sp>
            <p:cxnSp>
              <p:nvCxnSpPr>
                <p:cNvPr id="50" name="Straight Connector 49"/>
                <p:cNvCxnSpPr/>
                <p:nvPr/>
              </p:nvCxnSpPr>
              <p:spPr>
                <a:xfrm flipV="1">
                  <a:off x="2816262" y="3490526"/>
                  <a:ext cx="1242441" cy="1410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1" name="TextBox 50"/>
                <p:cNvSpPr txBox="1"/>
                <p:nvPr/>
              </p:nvSpPr>
              <p:spPr>
                <a:xfrm>
                  <a:off x="2771723" y="3510894"/>
                  <a:ext cx="1265437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 clones expressing NRAS G12D</a:t>
                  </a:r>
                </a:p>
              </p:txBody>
            </p:sp>
          </p:grpSp>
          <p:sp>
            <p:nvSpPr>
              <p:cNvPr id="52" name="TextBox 51"/>
              <p:cNvSpPr txBox="1"/>
              <p:nvPr/>
            </p:nvSpPr>
            <p:spPr>
              <a:xfrm>
                <a:off x="322323" y="1069742"/>
                <a:ext cx="27992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grpSp>
          <p:nvGrpSpPr>
            <p:cNvPr id="85" name="Group 84"/>
            <p:cNvGrpSpPr/>
            <p:nvPr/>
          </p:nvGrpSpPr>
          <p:grpSpPr>
            <a:xfrm>
              <a:off x="3334698" y="864002"/>
              <a:ext cx="2922183" cy="3692117"/>
              <a:chOff x="3334698" y="864002"/>
              <a:chExt cx="2922183" cy="3692117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3374052" y="864002"/>
                <a:ext cx="3829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graphicFrame>
            <p:nvGraphicFramePr>
              <p:cNvPr id="5" name="Object 4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677899569"/>
                  </p:ext>
                </p:extLst>
              </p:nvPr>
            </p:nvGraphicFramePr>
            <p:xfrm>
              <a:off x="3653381" y="1325563"/>
              <a:ext cx="2603500" cy="1997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6" imgW="3026220" imgH="2317591" progId="Prism9.Document">
                      <p:embed/>
                    </p:oleObj>
                  </mc:Choice>
                  <mc:Fallback>
                    <p:oleObj name="Prism 9" r:id="rId6" imgW="3026220" imgH="2317591" progId="Prism9.Document">
                      <p:embed/>
                      <p:pic>
                        <p:nvPicPr>
                          <p:cNvPr id="5" name="Object 4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3653381" y="1325563"/>
                            <a:ext cx="2603500" cy="1997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pSp>
            <p:nvGrpSpPr>
              <p:cNvPr id="11" name="Group 10"/>
              <p:cNvGrpSpPr/>
              <p:nvPr/>
            </p:nvGrpSpPr>
            <p:grpSpPr>
              <a:xfrm>
                <a:off x="4079923" y="3109199"/>
                <a:ext cx="1585047" cy="1446920"/>
                <a:chOff x="3933619" y="2853167"/>
                <a:chExt cx="1585047" cy="1446920"/>
              </a:xfrm>
            </p:grpSpPr>
            <p:sp>
              <p:nvSpPr>
                <p:cNvPr id="61" name="TextBox 60"/>
                <p:cNvSpPr txBox="1"/>
                <p:nvPr/>
              </p:nvSpPr>
              <p:spPr>
                <a:xfrm rot="16200000">
                  <a:off x="3694238" y="3127576"/>
                  <a:ext cx="7557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</a:t>
                  </a: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 rot="16200000">
                  <a:off x="4080273" y="3089228"/>
                  <a:ext cx="7491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  </a:t>
                  </a: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 rot="16200000">
                  <a:off x="4464042" y="3112728"/>
                  <a:ext cx="7090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4</a:t>
                  </a: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 rot="16200000">
                  <a:off x="4765333" y="3140712"/>
                  <a:ext cx="8186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5</a:t>
                  </a: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4253229" y="3653756"/>
                  <a:ext cx="1265437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 clones expressing NRAS G12D</a:t>
                  </a:r>
                </a:p>
              </p:txBody>
            </p:sp>
            <p:cxnSp>
              <p:nvCxnSpPr>
                <p:cNvPr id="66" name="Straight Connector 65"/>
                <p:cNvCxnSpPr/>
                <p:nvPr/>
              </p:nvCxnSpPr>
              <p:spPr>
                <a:xfrm flipV="1">
                  <a:off x="4332254" y="3637608"/>
                  <a:ext cx="1005840" cy="1410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7" name="TextBox 66"/>
              <p:cNvSpPr txBox="1"/>
              <p:nvPr/>
            </p:nvSpPr>
            <p:spPr>
              <a:xfrm rot="16200000">
                <a:off x="2718451" y="2074836"/>
                <a:ext cx="169416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FLAG/GAPDH)</a:t>
                </a:r>
              </a:p>
            </p:txBody>
          </p:sp>
        </p:grpSp>
        <p:grpSp>
          <p:nvGrpSpPr>
            <p:cNvPr id="84" name="Group 83"/>
            <p:cNvGrpSpPr/>
            <p:nvPr/>
          </p:nvGrpSpPr>
          <p:grpSpPr>
            <a:xfrm>
              <a:off x="5754827" y="864002"/>
              <a:ext cx="2964267" cy="3689834"/>
              <a:chOff x="5754827" y="864002"/>
              <a:chExt cx="2964267" cy="3689834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5833536" y="864002"/>
                <a:ext cx="3829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graphicFrame>
            <p:nvGraphicFramePr>
              <p:cNvPr id="7" name="Object 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36370796"/>
                  </p:ext>
                </p:extLst>
              </p:nvPr>
            </p:nvGraphicFramePr>
            <p:xfrm>
              <a:off x="6114006" y="1320800"/>
              <a:ext cx="2605088" cy="1997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8" imgW="3026220" imgH="2317591" progId="Prism9.Document">
                      <p:embed/>
                    </p:oleObj>
                  </mc:Choice>
                  <mc:Fallback>
                    <p:oleObj name="Prism 9" r:id="rId8" imgW="3026220" imgH="2317591" progId="Prism9.Document">
                      <p:embed/>
                      <p:pic>
                        <p:nvPicPr>
                          <p:cNvPr id="7" name="Object 6"/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6114006" y="1320800"/>
                            <a:ext cx="2605088" cy="1997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8" name="TextBox 67"/>
              <p:cNvSpPr txBox="1"/>
              <p:nvPr/>
            </p:nvSpPr>
            <p:spPr>
              <a:xfrm rot="16200000">
                <a:off x="5138580" y="2162373"/>
                <a:ext cx="169416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RAS G12D/GAPDH)</a:t>
                </a:r>
              </a:p>
            </p:txBody>
          </p:sp>
          <p:grpSp>
            <p:nvGrpSpPr>
              <p:cNvPr id="70" name="Group 69"/>
              <p:cNvGrpSpPr/>
              <p:nvPr/>
            </p:nvGrpSpPr>
            <p:grpSpPr>
              <a:xfrm>
                <a:off x="6568847" y="3070732"/>
                <a:ext cx="1558630" cy="1483104"/>
                <a:chOff x="3960036" y="2816983"/>
                <a:chExt cx="1558630" cy="1483104"/>
              </a:xfrm>
            </p:grpSpPr>
            <p:sp>
              <p:nvSpPr>
                <p:cNvPr id="71" name="TextBox 70"/>
                <p:cNvSpPr txBox="1"/>
                <p:nvPr/>
              </p:nvSpPr>
              <p:spPr>
                <a:xfrm rot="16200000">
                  <a:off x="3685262" y="3091757"/>
                  <a:ext cx="82654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</a:t>
                  </a: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 rot="16200000">
                  <a:off x="4080273" y="3089228"/>
                  <a:ext cx="7491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  </a:t>
                  </a: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 rot="16200000">
                  <a:off x="4464042" y="3112728"/>
                  <a:ext cx="7090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4</a:t>
                  </a:r>
                </a:p>
              </p:txBody>
            </p:sp>
            <p:sp>
              <p:nvSpPr>
                <p:cNvPr id="74" name="TextBox 73"/>
                <p:cNvSpPr txBox="1"/>
                <p:nvPr/>
              </p:nvSpPr>
              <p:spPr>
                <a:xfrm rot="16200000">
                  <a:off x="4765333" y="3140712"/>
                  <a:ext cx="8186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5</a:t>
                  </a:r>
                </a:p>
              </p:txBody>
            </p:sp>
            <p:sp>
              <p:nvSpPr>
                <p:cNvPr id="75" name="TextBox 74"/>
                <p:cNvSpPr txBox="1"/>
                <p:nvPr/>
              </p:nvSpPr>
              <p:spPr>
                <a:xfrm>
                  <a:off x="4253229" y="3653756"/>
                  <a:ext cx="1265437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 clones expressing NRAS G12D</a:t>
                  </a:r>
                </a:p>
              </p:txBody>
            </p:sp>
            <p:cxnSp>
              <p:nvCxnSpPr>
                <p:cNvPr id="76" name="Straight Connector 75"/>
                <p:cNvCxnSpPr/>
                <p:nvPr/>
              </p:nvCxnSpPr>
              <p:spPr>
                <a:xfrm flipV="1">
                  <a:off x="4332254" y="3637608"/>
                  <a:ext cx="1005840" cy="1410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5" name="Group 54"/>
            <p:cNvGrpSpPr/>
            <p:nvPr/>
          </p:nvGrpSpPr>
          <p:grpSpPr>
            <a:xfrm>
              <a:off x="8117586" y="848613"/>
              <a:ext cx="2978948" cy="3704319"/>
              <a:chOff x="8117586" y="848613"/>
              <a:chExt cx="2978948" cy="3704319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8176371" y="848613"/>
                <a:ext cx="34409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graphicFrame>
            <p:nvGraphicFramePr>
              <p:cNvPr id="6" name="Object 5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810467539"/>
                  </p:ext>
                </p:extLst>
              </p:nvPr>
            </p:nvGraphicFramePr>
            <p:xfrm>
              <a:off x="8491446" y="1326198"/>
              <a:ext cx="2605088" cy="1997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10" imgW="3027661" imgH="2317591" progId="Prism8.Document">
                      <p:embed/>
                    </p:oleObj>
                  </mc:Choice>
                  <mc:Fallback>
                    <p:oleObj name="Prism 8" r:id="rId10" imgW="3027661" imgH="2317591" progId="Prism8.Document">
                      <p:embed/>
                      <p:pic>
                        <p:nvPicPr>
                          <p:cNvPr id="6" name="Object 5"/>
                          <p:cNvPicPr/>
                          <p:nvPr/>
                        </p:nvPicPr>
                        <p:blipFill>
                          <a:blip r:embed="rId11"/>
                          <a:stretch>
                            <a:fillRect/>
                          </a:stretch>
                        </p:blipFill>
                        <p:spPr>
                          <a:xfrm>
                            <a:off x="8491446" y="1326198"/>
                            <a:ext cx="2605088" cy="1997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9" name="TextBox 68"/>
              <p:cNvSpPr txBox="1"/>
              <p:nvPr/>
            </p:nvSpPr>
            <p:spPr>
              <a:xfrm rot="16200000">
                <a:off x="7501339" y="2161096"/>
                <a:ext cx="169416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 in ratio (RAS/GAPDH)</a:t>
                </a:r>
              </a:p>
            </p:txBody>
          </p:sp>
          <p:grpSp>
            <p:nvGrpSpPr>
              <p:cNvPr id="77" name="Group 76"/>
              <p:cNvGrpSpPr/>
              <p:nvPr/>
            </p:nvGrpSpPr>
            <p:grpSpPr>
              <a:xfrm>
                <a:off x="8942462" y="3079611"/>
                <a:ext cx="1576386" cy="1473321"/>
                <a:chOff x="3942280" y="2826766"/>
                <a:chExt cx="1576386" cy="1473321"/>
              </a:xfrm>
            </p:grpSpPr>
            <p:sp>
              <p:nvSpPr>
                <p:cNvPr id="78" name="TextBox 77"/>
                <p:cNvSpPr txBox="1"/>
                <p:nvPr/>
              </p:nvSpPr>
              <p:spPr>
                <a:xfrm rot="16200000">
                  <a:off x="3667958" y="3101088"/>
                  <a:ext cx="82564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</a:t>
                  </a:r>
                </a:p>
              </p:txBody>
            </p:sp>
            <p:sp>
              <p:nvSpPr>
                <p:cNvPr id="79" name="TextBox 78"/>
                <p:cNvSpPr txBox="1"/>
                <p:nvPr/>
              </p:nvSpPr>
              <p:spPr>
                <a:xfrm rot="16200000">
                  <a:off x="4080273" y="3089228"/>
                  <a:ext cx="7491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  </a:t>
                  </a:r>
                </a:p>
              </p:txBody>
            </p:sp>
            <p:sp>
              <p:nvSpPr>
                <p:cNvPr id="80" name="TextBox 79"/>
                <p:cNvSpPr txBox="1"/>
                <p:nvPr/>
              </p:nvSpPr>
              <p:spPr>
                <a:xfrm rot="16200000">
                  <a:off x="4464042" y="3112728"/>
                  <a:ext cx="7090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4</a:t>
                  </a: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 rot="16200000">
                  <a:off x="4765333" y="3140712"/>
                  <a:ext cx="81863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one 15</a:t>
                  </a: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4253229" y="3653756"/>
                  <a:ext cx="1265437" cy="6463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V-4-11 clones expressing NRAS G12D</a:t>
                  </a:r>
                </a:p>
              </p:txBody>
            </p:sp>
            <p:cxnSp>
              <p:nvCxnSpPr>
                <p:cNvPr id="83" name="Straight Connector 82"/>
                <p:cNvCxnSpPr/>
                <p:nvPr/>
              </p:nvCxnSpPr>
              <p:spPr>
                <a:xfrm flipV="1">
                  <a:off x="4332254" y="3637608"/>
                  <a:ext cx="1005840" cy="1410"/>
                </a:xfrm>
                <a:prstGeom prst="line">
                  <a:avLst/>
                </a:prstGeom>
                <a:ln>
                  <a:solidFill>
                    <a:schemeClr val="tx1">
                      <a:lumMod val="95000"/>
                      <a:lumOff val="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" name="Rectangle 1"/>
          <p:cNvSpPr/>
          <p:nvPr/>
        </p:nvSpPr>
        <p:spPr>
          <a:xfrm>
            <a:off x="630598" y="4975014"/>
            <a:ext cx="10807432" cy="7838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8.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estern blot analysis of total cell lysates from parental MV-4-11 and clones engineered to express NRAS</a:t>
            </a:r>
            <a:r>
              <a:rPr lang="en-US" sz="14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12D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ntaining a FLAG tag probed with anti-FLAG, anti-RAS G12D, anti-RAS and anti-GAPDH. A representative blot is shown in panel A. Quantification of band intensities from 3 blots for the indicted proteins is shown in B-D. Data is mean ± SEM.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9434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39</TotalTime>
  <Words>151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rism 8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19</cp:revision>
  <cp:lastPrinted>2024-09-20T16:49:30Z</cp:lastPrinted>
  <dcterms:created xsi:type="dcterms:W3CDTF">2023-07-11T20:23:00Z</dcterms:created>
  <dcterms:modified xsi:type="dcterms:W3CDTF">2024-11-11T03:13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